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>
        <p:scale>
          <a:sx n="210" d="100"/>
          <a:sy n="210" d="100"/>
        </p:scale>
        <p:origin x="352" y="-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1891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573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9949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0383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067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043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1903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9965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5268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685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8764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4D340-70C1-4EF3-A881-8F145F4E958C}" type="datetimeFigureOut">
              <a:rPr lang="zh-CN" altLang="en-US" smtClean="0"/>
              <a:t>2022/12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C9E78-EEDC-4465-B637-F7949338CF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675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2363" y="958266"/>
            <a:ext cx="2044325" cy="2107469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8304" y="1062140"/>
            <a:ext cx="2602136" cy="1799289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673419" y="884624"/>
            <a:ext cx="16815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73419" y="3554671"/>
            <a:ext cx="16815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2213" y="3711490"/>
            <a:ext cx="1824541" cy="241297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0961" y="6695253"/>
            <a:ext cx="1335434" cy="175138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8297" y="3678777"/>
            <a:ext cx="2344206" cy="2478401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73419" y="6433131"/>
            <a:ext cx="16815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054210" y="884624"/>
            <a:ext cx="16815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50220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5D30C7A-8B2A-C19E-145B-9FD65688B976}"/>
              </a:ext>
            </a:extLst>
          </p:cNvPr>
          <p:cNvSpPr txBox="1"/>
          <p:nvPr/>
        </p:nvSpPr>
        <p:spPr>
          <a:xfrm>
            <a:off x="187569" y="597877"/>
            <a:ext cx="6817187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 OGT inhibition  reduces YTHDC1 chromatin binding and ionizing </a:t>
            </a:r>
          </a:p>
          <a:p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diation-induced focus (IRIF) formation.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marL="228600" indent="-228600">
              <a:buAutoNum type="alphaUcParenBoth"/>
            </a:pP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lls were transfected with YTHDC1-WT or -S396A plasmids and treated with IR, incubated </a:t>
            </a:r>
          </a:p>
          <a:p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ith the OGT inhibitor OSMI-1 or not. </a:t>
            </a:r>
          </a:p>
          <a:p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The GFP foci were quantitated. 45 cells were counted in each experiment.</a:t>
            </a:r>
            <a:r>
              <a:rPr lang="en-US" altLang="zh-CN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s: not significant;  **** indicates P&lt;0.0001.</a:t>
            </a:r>
          </a:p>
          <a:p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lls were transfected with GFP-YTHDC1-WT, or -S396A plasmids, then treated with 10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y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X-ray, </a:t>
            </a:r>
          </a:p>
          <a:p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cubated with the OGT inhibitor OSMI-1 or not. The cells were then stained with anti-γH2AX antibodies, </a:t>
            </a:r>
          </a:p>
          <a:p>
            <a:r>
              <a:rPr lang="en-US" altLang="zh-CN" sz="12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number of colocalization foci </a:t>
            </a:r>
            <a:r>
              <a:rPr lang="en-US" altLang="zh-CN" sz="12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ere quantitated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(D). **** indicates: P&lt;0.0001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endParaRPr kumimoji="1"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9343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3</TotalTime>
  <Words>131</Words>
  <Application>Microsoft Macintosh PowerPoint</Application>
  <PresentationFormat>A4 纸张(210x297 毫米)</PresentationFormat>
  <Paragraphs>1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</dc:creator>
  <cp:lastModifiedBy>office user</cp:lastModifiedBy>
  <cp:revision>7</cp:revision>
  <dcterms:created xsi:type="dcterms:W3CDTF">2022-12-07T13:03:16Z</dcterms:created>
  <dcterms:modified xsi:type="dcterms:W3CDTF">2022-12-31T15:03:25Z</dcterms:modified>
</cp:coreProperties>
</file>